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6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2910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95387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99147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48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243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2526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8784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5552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3141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3414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65171-FBB8-4963-94F6-F6362E8D5168}" type="datetimeFigureOut">
              <a:rPr lang="en-IN" smtClean="0"/>
              <a:t>02-10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25442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7F0E194-5810-4BCE-A92A-51BE774787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4517407"/>
              </p:ext>
            </p:extLst>
          </p:nvPr>
        </p:nvGraphicFramePr>
        <p:xfrm>
          <a:off x="1825932" y="617375"/>
          <a:ext cx="2857245" cy="2730508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1593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79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0337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ame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th (metres below surface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344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Core 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1.50-1681.66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344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Core 2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1.18-1901.33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344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Core 3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3.69-2093.73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344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Core 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35.60-2335.6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344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Core 6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62.00-2662.0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344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Core 7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08.50-2908.5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2" marR="68572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3F3F4E3-75DD-43BC-88EF-036A7B1D5595}"/>
              </a:ext>
            </a:extLst>
          </p:cNvPr>
          <p:cNvGraphicFramePr>
            <a:graphicFrameLocks noGrp="1"/>
          </p:cNvGraphicFramePr>
          <p:nvPr/>
        </p:nvGraphicFramePr>
        <p:xfrm>
          <a:off x="155986" y="4508659"/>
          <a:ext cx="2211232" cy="523716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5054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57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57252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 medium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0923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eral elements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s (g/L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OH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0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6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32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5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10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8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957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N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for Bicarbonate enrichment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919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919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S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7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341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ce element solution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745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tamin solution(Kao and </a:t>
                      </a:r>
                      <a:r>
                        <a:rPr lang="en-IN" sz="1000" b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hayluk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PL020, </a:t>
                      </a:r>
                      <a:r>
                        <a:rPr lang="en-IN" sz="1000" b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media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65" marR="6856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F1ADB51-93D6-4A1C-AB47-9960A1D831AA}"/>
              </a:ext>
            </a:extLst>
          </p:cNvPr>
          <p:cNvGraphicFramePr>
            <a:graphicFrameLocks noGrp="1"/>
          </p:cNvGraphicFramePr>
          <p:nvPr/>
        </p:nvGraphicFramePr>
        <p:xfrm>
          <a:off x="2470406" y="4519772"/>
          <a:ext cx="2204833" cy="523874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3850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980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39548">
                <a:tc gridSpan="2">
                  <a:txBody>
                    <a:bodyPr/>
                    <a:lstStyle/>
                    <a:p>
                      <a:pPr marL="457200"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ce element 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ution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873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eral elements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s (g/L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S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7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n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4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0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.2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000" b="1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082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Cd(SO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3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]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0438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rCl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H</a:t>
                      </a:r>
                      <a:r>
                        <a:rPr lang="en-IN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0" marR="58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2FC08DD-20F9-4B97-9321-10697AA9A18B}"/>
              </a:ext>
            </a:extLst>
          </p:cNvPr>
          <p:cNvGraphicFramePr>
            <a:graphicFrameLocks noGrp="1"/>
          </p:cNvGraphicFramePr>
          <p:nvPr/>
        </p:nvGraphicFramePr>
        <p:xfrm>
          <a:off x="4675239" y="4508659"/>
          <a:ext cx="2211232" cy="2666999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7415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370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561943"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t up _1 : H</a:t>
                      </a:r>
                      <a:r>
                        <a:rPr lang="en-US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CO</a:t>
                      </a:r>
                      <a:r>
                        <a:rPr lang="en-US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t (HC)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er 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7106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nents 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s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348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 Medium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970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CO</a:t>
                      </a:r>
                      <a:r>
                        <a:rPr lang="en-US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as (80:20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970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ate (as TEA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mM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970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powder sample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g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67" marR="58067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E9C3AA9-7C42-4961-AB48-050EA25834A0}"/>
              </a:ext>
            </a:extLst>
          </p:cNvPr>
          <p:cNvGraphicFramePr>
            <a:graphicFrameLocks noGrp="1"/>
          </p:cNvGraphicFramePr>
          <p:nvPr/>
        </p:nvGraphicFramePr>
        <p:xfrm>
          <a:off x="4683177" y="7251859"/>
          <a:ext cx="2204833" cy="250507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675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3725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86532"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t up _2 : Bicarbonate  set (BC)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er 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443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nents 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97" marR="68597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s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97" marR="68597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25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 Medium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ml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4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O</a:t>
                      </a:r>
                      <a:r>
                        <a:rPr lang="en-US" sz="1000" b="1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000" b="1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IN" sz="1000" b="1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mM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2261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xture</a:t>
                      </a:r>
                      <a:r>
                        <a:rPr lang="en-US" sz="1000" b="1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n-US" sz="1000" b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ate+Nitrate+Fe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II)+</a:t>
                      </a:r>
                      <a:r>
                        <a:rPr lang="en-US" sz="1000" b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n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V) (as TEA)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mM each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94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k powder sample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731510" algn="l"/>
                        </a:tabLs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g</a:t>
                      </a:r>
                      <a:endParaRPr lang="en-IN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8081" marR="58081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07DE82E4-472A-4F57-AF44-332E68E0B614}"/>
              </a:ext>
            </a:extLst>
          </p:cNvPr>
          <p:cNvSpPr txBox="1"/>
          <p:nvPr/>
        </p:nvSpPr>
        <p:spPr>
          <a:xfrm>
            <a:off x="1101969" y="65874"/>
            <a:ext cx="4587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table 1: Sample name and depth  details</a:t>
            </a:r>
            <a:endParaRPr kumimoji="0" lang="en-IN" sz="1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8" name="TextBox 8">
            <a:extLst>
              <a:ext uri="{FF2B5EF4-FFF2-40B4-BE49-F238E27FC236}">
                <a16:creationId xmlns:a16="http://schemas.microsoft.com/office/drawing/2014/main" id="{90157077-F848-42B7-B303-66F7C0CD8C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625" y="3717915"/>
            <a:ext cx="6352390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table 2:</a:t>
            </a:r>
            <a:r>
              <a:rPr kumimoji="0" lang="en-IN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US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ailed Composition of the enrichment setups used for reactivation of indigenous microbes. </a:t>
            </a:r>
            <a:r>
              <a:rPr lang="en-IN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dium </a:t>
            </a:r>
            <a:r>
              <a:rPr lang="en-IN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lfate</a:t>
            </a:r>
            <a:r>
              <a:rPr lang="en-IN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set up 1), Sodium </a:t>
            </a:r>
            <a:r>
              <a:rPr lang="en-IN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lfate</a:t>
            </a:r>
            <a:r>
              <a:rPr lang="en-IN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erric chloride, </a:t>
            </a:r>
            <a:r>
              <a:rPr lang="en-IN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ttasium</a:t>
            </a:r>
            <a:r>
              <a:rPr lang="en-IN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itrate and manganese dioxide (set up 2), were used as TEA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altLang="en-US" sz="1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C71D66-65AC-D8D1-FDCD-8BFEE547A899}"/>
              </a:ext>
            </a:extLst>
          </p:cNvPr>
          <p:cNvSpPr txBox="1"/>
          <p:nvPr/>
        </p:nvSpPr>
        <p:spPr>
          <a:xfrm>
            <a:off x="6948767" y="4383152"/>
            <a:ext cx="6962215" cy="311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IN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3330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68</Words>
  <Application>Microsoft Office PowerPoint</Application>
  <PresentationFormat>A4 Paper (210x297 mm)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ANDA MANDAL</dc:creator>
  <cp:lastModifiedBy>SUNANDA MANDAL</cp:lastModifiedBy>
  <cp:revision>3</cp:revision>
  <dcterms:created xsi:type="dcterms:W3CDTF">2022-08-11T19:48:06Z</dcterms:created>
  <dcterms:modified xsi:type="dcterms:W3CDTF">2022-10-01T21:52:56Z</dcterms:modified>
</cp:coreProperties>
</file>